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AB8478-1EDD-4460-A091-5361C53D28F8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29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. S10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WSC losses affect multiple primary and secondly metabolism pathways. Mutant of WSC leads to a coordinated increase in transcript and metabolic levels of carbon metabolism pathways and hormone synthesis and signaling pathways while the flavonoids metabolism pathway was redirected. Up- and down-regulated genes and metabolites are shown in red and green, respectively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3D66CB-5A44-46EE-80C7-45C651066547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E60E37-09B8-40C8-B8BD-12871D3B6A0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A2B626-660C-44EC-B6AC-D75A8057B2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34B45-63EC-4AB8-98CC-3FC619CC402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209F1-27A2-4AB2-95EA-18BBCB8B4D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70D4C5-DAB5-4181-BACD-D6DCAEDBB2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B3DEB8-C51F-4683-96B5-148EFB986F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950962-D80D-4BA4-B764-3EAF6CFE14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F2221A-F15C-497A-B89C-2D10566ED9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ED490-C949-49C0-93BF-CF9A3FB42A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5E8A87-E4F2-426F-9581-E6AF3B4828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5B5444-DFAE-4BA1-BF73-1C3AC92DE1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902AE-D9A8-48B6-8E0F-7B9A31C0BF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4DD870-3B87-49EF-A2EE-C3FD0AF3C5C5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组合 236"/>
          <p:cNvGrpSpPr/>
          <p:nvPr/>
        </p:nvGrpSpPr>
        <p:grpSpPr>
          <a:xfrm>
            <a:off x="4708440" y="7920"/>
            <a:ext cx="3578400" cy="5688720"/>
            <a:chOff x="4708440" y="7920"/>
            <a:chExt cx="3578400" cy="5688720"/>
          </a:xfrm>
        </p:grpSpPr>
        <p:sp>
          <p:nvSpPr>
            <p:cNvPr id="49" name="圆角矩形 5"/>
            <p:cNvSpPr/>
            <p:nvPr/>
          </p:nvSpPr>
          <p:spPr>
            <a:xfrm flipV="1">
              <a:off x="4708440" y="7560"/>
              <a:ext cx="2097360" cy="5207040"/>
            </a:xfrm>
            <a:custGeom>
              <a:avLst/>
              <a:gdLst>
                <a:gd name="textAreaLeft" fmla="*/ 102240 w 2097360"/>
                <a:gd name="textAreaRight" fmla="*/ 1995120 w 2097360"/>
                <a:gd name="textAreaTop" fmla="*/ 102240 h 5207040"/>
                <a:gd name="textAreaBottom" fmla="*/ 5104800 h 5207040"/>
              </a:gdLst>
              <a:ahLst/>
              <a:rect l="textAreaLeft" t="textAreaTop" r="textAreaRight" b="textAreaBottom"/>
              <a:pathLst>
                <a:path w="21600" h="53620">
                  <a:moveTo>
                    <a:pt x="3600" y="0"/>
                  </a:moveTo>
                  <a:arcTo wR="3600" hR="3600" stAng="16200000" swAng="-5400000"/>
                  <a:lnTo>
                    <a:pt x="0" y="50020"/>
                  </a:lnTo>
                  <a:arcTo wR="3600" hR="3600" stAng="10800000" swAng="-5400000"/>
                  <a:lnTo>
                    <a:pt x="18000" y="53620"/>
                  </a:lnTo>
                  <a:arcTo wR="3600" hR="3600" stAng="5400000" swAng="-5400000"/>
                  <a:lnTo>
                    <a:pt x="21600" y="3600"/>
                  </a:lnTo>
                  <a:arcTo wR="3600" hR="3600" stAng="0" swAng="-5400000"/>
                  <a:close/>
                </a:path>
              </a:pathLst>
            </a:cu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矩形 8"/>
            <p:cNvSpPr/>
            <p:nvPr/>
          </p:nvSpPr>
          <p:spPr>
            <a:xfrm>
              <a:off x="4857840" y="61200"/>
              <a:ext cx="3429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Times New Roman"/>
                </a:rPr>
                <a:t>Jasmonic acid biosynthesis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直接连接符 23"/>
            <p:cNvSpPr/>
            <p:nvPr/>
          </p:nvSpPr>
          <p:spPr>
            <a:xfrm>
              <a:off x="4916160" y="558504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24"/>
            <p:cNvSpPr/>
            <p:nvPr/>
          </p:nvSpPr>
          <p:spPr>
            <a:xfrm>
              <a:off x="5426280" y="5450400"/>
              <a:ext cx="228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Saturated fatty acid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直接连接符 26"/>
            <p:cNvSpPr/>
            <p:nvPr/>
          </p:nvSpPr>
          <p:spPr>
            <a:xfrm flipV="1">
              <a:off x="5922720" y="4965840"/>
              <a:ext cx="0" cy="50472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27"/>
            <p:cNvSpPr/>
            <p:nvPr/>
          </p:nvSpPr>
          <p:spPr>
            <a:xfrm>
              <a:off x="5541120" y="4795560"/>
              <a:ext cx="150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α-linolenat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直接连接符 28"/>
            <p:cNvSpPr/>
            <p:nvPr/>
          </p:nvSpPr>
          <p:spPr>
            <a:xfrm flipV="1">
              <a:off x="5922720" y="4362840"/>
              <a:ext cx="0" cy="431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29"/>
            <p:cNvSpPr/>
            <p:nvPr/>
          </p:nvSpPr>
          <p:spPr>
            <a:xfrm>
              <a:off x="5915160" y="4340880"/>
              <a:ext cx="78588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LOX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LOX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LOX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直接连接符 31"/>
            <p:cNvSpPr/>
            <p:nvPr/>
          </p:nvSpPr>
          <p:spPr>
            <a:xfrm flipH="1" flipV="1">
              <a:off x="5637240" y="4482000"/>
              <a:ext cx="142560" cy="28548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35"/>
            <p:cNvSpPr/>
            <p:nvPr/>
          </p:nvSpPr>
          <p:spPr>
            <a:xfrm>
              <a:off x="5156280" y="4300920"/>
              <a:ext cx="749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Traumat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36"/>
            <p:cNvSpPr/>
            <p:nvPr/>
          </p:nvSpPr>
          <p:spPr>
            <a:xfrm>
              <a:off x="5267520" y="4521600"/>
              <a:ext cx="512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HPL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直接连接符 37"/>
            <p:cNvSpPr/>
            <p:nvPr/>
          </p:nvSpPr>
          <p:spPr>
            <a:xfrm flipV="1">
              <a:off x="5910120" y="3832560"/>
              <a:ext cx="0" cy="215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38"/>
            <p:cNvSpPr/>
            <p:nvPr/>
          </p:nvSpPr>
          <p:spPr>
            <a:xfrm>
              <a:off x="5160240" y="3646440"/>
              <a:ext cx="2714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2,13(S)-epoxylinolenat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39"/>
            <p:cNvSpPr/>
            <p:nvPr/>
          </p:nvSpPr>
          <p:spPr>
            <a:xfrm>
              <a:off x="5946840" y="3798000"/>
              <a:ext cx="1214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YP74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直接连接符 40"/>
            <p:cNvSpPr/>
            <p:nvPr/>
          </p:nvSpPr>
          <p:spPr>
            <a:xfrm flipV="1">
              <a:off x="5922720" y="3256200"/>
              <a:ext cx="0" cy="433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41"/>
            <p:cNvSpPr/>
            <p:nvPr/>
          </p:nvSpPr>
          <p:spPr>
            <a:xfrm>
              <a:off x="4923000" y="3067920"/>
              <a:ext cx="2714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2-oxo-cis-10,15-phytodienoat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42"/>
            <p:cNvSpPr/>
            <p:nvPr/>
          </p:nvSpPr>
          <p:spPr>
            <a:xfrm>
              <a:off x="5925600" y="3372480"/>
              <a:ext cx="8571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Times New Roman"/>
                </a:rPr>
                <a:t>AO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直接连接符 43"/>
            <p:cNvSpPr/>
            <p:nvPr/>
          </p:nvSpPr>
          <p:spPr>
            <a:xfrm flipV="1">
              <a:off x="5922720" y="2899080"/>
              <a:ext cx="0" cy="215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44"/>
            <p:cNvSpPr/>
            <p:nvPr/>
          </p:nvSpPr>
          <p:spPr>
            <a:xfrm>
              <a:off x="5196600" y="2529720"/>
              <a:ext cx="17254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3-oxo-2-(cis-2’-pentenyl)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yclopentane-1-octanoat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45"/>
            <p:cNvSpPr/>
            <p:nvPr/>
          </p:nvSpPr>
          <p:spPr>
            <a:xfrm>
              <a:off x="5921280" y="2883960"/>
              <a:ext cx="857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Times New Roman"/>
                </a:rPr>
                <a:t>OP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直接连接符 46"/>
            <p:cNvSpPr/>
            <p:nvPr/>
          </p:nvSpPr>
          <p:spPr>
            <a:xfrm flipV="1">
              <a:off x="5922720" y="2367360"/>
              <a:ext cx="0" cy="215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47"/>
            <p:cNvSpPr/>
            <p:nvPr/>
          </p:nvSpPr>
          <p:spPr>
            <a:xfrm>
              <a:off x="5922000" y="2337480"/>
              <a:ext cx="857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PCL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48"/>
            <p:cNvSpPr/>
            <p:nvPr/>
          </p:nvSpPr>
          <p:spPr>
            <a:xfrm>
              <a:off x="5168520" y="2171880"/>
              <a:ext cx="157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PC6-trans-2-enoyl-Co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直接连接符 49"/>
            <p:cNvSpPr/>
            <p:nvPr/>
          </p:nvSpPr>
          <p:spPr>
            <a:xfrm flipV="1">
              <a:off x="5929200" y="2011680"/>
              <a:ext cx="0" cy="2156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50"/>
            <p:cNvSpPr/>
            <p:nvPr/>
          </p:nvSpPr>
          <p:spPr>
            <a:xfrm>
              <a:off x="5160960" y="1840320"/>
              <a:ext cx="157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PC4-trans-2-enoyl-Co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直接连接符 51"/>
            <p:cNvSpPr/>
            <p:nvPr/>
          </p:nvSpPr>
          <p:spPr>
            <a:xfrm flipV="1">
              <a:off x="5933880" y="1681200"/>
              <a:ext cx="0" cy="215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Box 52"/>
            <p:cNvSpPr/>
            <p:nvPr/>
          </p:nvSpPr>
          <p:spPr>
            <a:xfrm>
              <a:off x="5298480" y="1524240"/>
              <a:ext cx="207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(+-)-7-iso-jasmonat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直接连接符 53"/>
            <p:cNvSpPr/>
            <p:nvPr/>
          </p:nvSpPr>
          <p:spPr>
            <a:xfrm flipV="1">
              <a:off x="5933880" y="1368720"/>
              <a:ext cx="0" cy="215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Box 54"/>
            <p:cNvSpPr/>
            <p:nvPr/>
          </p:nvSpPr>
          <p:spPr>
            <a:xfrm>
              <a:off x="5384520" y="1167840"/>
              <a:ext cx="207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(-)-7-iso-jasmonat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直接连接符 55"/>
            <p:cNvSpPr/>
            <p:nvPr/>
          </p:nvSpPr>
          <p:spPr>
            <a:xfrm flipV="1">
              <a:off x="5933880" y="993960"/>
              <a:ext cx="0" cy="2156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56"/>
            <p:cNvSpPr/>
            <p:nvPr/>
          </p:nvSpPr>
          <p:spPr>
            <a:xfrm>
              <a:off x="5509800" y="822960"/>
              <a:ext cx="91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(-)-jasmonat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直接连接符 57"/>
            <p:cNvSpPr/>
            <p:nvPr/>
          </p:nvSpPr>
          <p:spPr>
            <a:xfrm flipV="1">
              <a:off x="5940360" y="650880"/>
              <a:ext cx="0" cy="215640"/>
            </a:xfrm>
            <a:prstGeom prst="line">
              <a:avLst/>
            </a:prstGeom>
            <a:ln w="19080">
              <a:solidFill>
                <a:srgbClr val="000000"/>
              </a:solidFill>
              <a:prstDash val="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58"/>
            <p:cNvSpPr/>
            <p:nvPr/>
          </p:nvSpPr>
          <p:spPr>
            <a:xfrm>
              <a:off x="4949640" y="471960"/>
              <a:ext cx="207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2-hydroxy jasmonate sulphat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2" name="椭圆 144"/>
          <p:cNvSpPr/>
          <p:nvPr/>
        </p:nvSpPr>
        <p:spPr>
          <a:xfrm>
            <a:off x="2448000" y="3755880"/>
            <a:ext cx="1220760" cy="1220760"/>
          </a:xfrm>
          <a:prstGeom prst="ellipse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圆角矩形 6"/>
          <p:cNvSpPr/>
          <p:nvPr/>
        </p:nvSpPr>
        <p:spPr>
          <a:xfrm>
            <a:off x="4643280" y="5865840"/>
            <a:ext cx="2144880" cy="2843280"/>
          </a:xfrm>
          <a:custGeom>
            <a:avLst/>
            <a:gdLst>
              <a:gd name="textAreaLeft" fmla="*/ 104400 w 2144880"/>
              <a:gd name="textAreaRight" fmla="*/ 2040480 w 2144880"/>
              <a:gd name="textAreaTop" fmla="*/ 104400 h 2843280"/>
              <a:gd name="textAreaBottom" fmla="*/ 2738880 h 2843280"/>
            </a:gdLst>
            <a:ahLst/>
            <a:rect l="textAreaLeft" t="textAreaTop" r="textAreaRight" b="textAreaBottom"/>
            <a:pathLst>
              <a:path w="21600" h="28632">
                <a:moveTo>
                  <a:pt x="3600" y="0"/>
                </a:moveTo>
                <a:arcTo wR="3600" hR="3600" stAng="16200000" swAng="-5400000"/>
                <a:lnTo>
                  <a:pt x="0" y="25032"/>
                </a:lnTo>
                <a:arcTo wR="3600" hR="3600" stAng="10800000" swAng="-5400000"/>
                <a:lnTo>
                  <a:pt x="18000" y="28632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矩形 7"/>
          <p:cNvSpPr/>
          <p:nvPr/>
        </p:nvSpPr>
        <p:spPr>
          <a:xfrm>
            <a:off x="5183280" y="8474040"/>
            <a:ext cx="342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Times New Roman"/>
              </a:rPr>
              <a:t>GA biosynthesi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30"/>
          <p:cNvSpPr/>
          <p:nvPr/>
        </p:nvSpPr>
        <p:spPr>
          <a:xfrm>
            <a:off x="4630680" y="4000680"/>
            <a:ext cx="2286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(9Z,11E,15Z)-(13S)-hydroperoxyoctadeca-9,11,15-trieno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圆角矩形 146"/>
          <p:cNvSpPr/>
          <p:nvPr/>
        </p:nvSpPr>
        <p:spPr>
          <a:xfrm>
            <a:off x="2428920" y="7723080"/>
            <a:ext cx="2143080" cy="1000080"/>
          </a:xfrm>
          <a:prstGeom prst="roundRect">
            <a:avLst>
              <a:gd name="adj" fmla="val 16667"/>
            </a:avLst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147"/>
          <p:cNvSpPr/>
          <p:nvPr/>
        </p:nvSpPr>
        <p:spPr>
          <a:xfrm>
            <a:off x="2500200" y="7723080"/>
            <a:ext cx="164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ABA Signal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162"/>
          <p:cNvSpPr/>
          <p:nvPr/>
        </p:nvSpPr>
        <p:spPr>
          <a:xfrm>
            <a:off x="2500200" y="7966080"/>
            <a:ext cx="1857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Auxin Signal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163"/>
          <p:cNvSpPr/>
          <p:nvPr/>
        </p:nvSpPr>
        <p:spPr>
          <a:xfrm>
            <a:off x="2529000" y="8217000"/>
            <a:ext cx="185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BR Signal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164"/>
          <p:cNvSpPr/>
          <p:nvPr/>
        </p:nvSpPr>
        <p:spPr>
          <a:xfrm>
            <a:off x="3500280" y="7715160"/>
            <a:ext cx="1857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TK Signal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166"/>
          <p:cNvSpPr/>
          <p:nvPr/>
        </p:nvSpPr>
        <p:spPr>
          <a:xfrm>
            <a:off x="3556080" y="7969320"/>
            <a:ext cx="185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 Signal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167"/>
          <p:cNvSpPr/>
          <p:nvPr/>
        </p:nvSpPr>
        <p:spPr>
          <a:xfrm>
            <a:off x="3535200" y="8242200"/>
            <a:ext cx="1857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JA Signal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150"/>
          <p:cNvSpPr/>
          <p:nvPr/>
        </p:nvSpPr>
        <p:spPr>
          <a:xfrm>
            <a:off x="2571840" y="4260960"/>
            <a:ext cx="92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Times New Roman"/>
              </a:rPr>
              <a:t>TCA cyc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4" name="组合 237"/>
          <p:cNvGrpSpPr/>
          <p:nvPr/>
        </p:nvGrpSpPr>
        <p:grpSpPr>
          <a:xfrm>
            <a:off x="71280" y="7560"/>
            <a:ext cx="4707000" cy="3708360"/>
            <a:chOff x="71280" y="7560"/>
            <a:chExt cx="4707000" cy="3708360"/>
          </a:xfrm>
        </p:grpSpPr>
        <p:sp>
          <p:nvSpPr>
            <p:cNvPr id="95" name="矩形 9"/>
            <p:cNvSpPr/>
            <p:nvPr/>
          </p:nvSpPr>
          <p:spPr>
            <a:xfrm>
              <a:off x="247320" y="208440"/>
              <a:ext cx="171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Flavonoid  metabolism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Box 124"/>
            <p:cNvSpPr/>
            <p:nvPr/>
          </p:nvSpPr>
          <p:spPr>
            <a:xfrm>
              <a:off x="2197800" y="658440"/>
              <a:ext cx="907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GT,AT,M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Box 125"/>
            <p:cNvSpPr/>
            <p:nvPr/>
          </p:nvSpPr>
          <p:spPr>
            <a:xfrm>
              <a:off x="2000160" y="364680"/>
              <a:ext cx="157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b050"/>
                  </a:solidFill>
                  <a:latin typeface="Times New Roman"/>
                </a:rPr>
                <a:t>Anthocyani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Box 68"/>
            <p:cNvSpPr/>
            <p:nvPr/>
          </p:nvSpPr>
          <p:spPr>
            <a:xfrm>
              <a:off x="1854720" y="2631960"/>
              <a:ext cx="64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TT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73"/>
            <p:cNvSpPr/>
            <p:nvPr/>
          </p:nvSpPr>
          <p:spPr>
            <a:xfrm>
              <a:off x="2215800" y="2345400"/>
              <a:ext cx="64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F3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110"/>
            <p:cNvSpPr/>
            <p:nvPr/>
          </p:nvSpPr>
          <p:spPr>
            <a:xfrm>
              <a:off x="2585880" y="1719360"/>
              <a:ext cx="64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b050"/>
                  </a:solidFill>
                  <a:latin typeface="Times New Roman"/>
                </a:rPr>
                <a:t>DR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Box 113"/>
            <p:cNvSpPr/>
            <p:nvPr/>
          </p:nvSpPr>
          <p:spPr>
            <a:xfrm>
              <a:off x="2190240" y="1249200"/>
              <a:ext cx="64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Box 112"/>
            <p:cNvSpPr/>
            <p:nvPr/>
          </p:nvSpPr>
          <p:spPr>
            <a:xfrm>
              <a:off x="660960" y="1248120"/>
              <a:ext cx="64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圆角矩形 3"/>
            <p:cNvSpPr/>
            <p:nvPr/>
          </p:nvSpPr>
          <p:spPr>
            <a:xfrm flipV="1">
              <a:off x="71280" y="21240"/>
              <a:ext cx="4577040" cy="3311640"/>
            </a:xfrm>
            <a:prstGeom prst="roundRect">
              <a:avLst>
                <a:gd name="adj" fmla="val 16667"/>
              </a:avLst>
            </a:prstGeom>
            <a:noFill/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Box 11"/>
            <p:cNvSpPr/>
            <p:nvPr/>
          </p:nvSpPr>
          <p:spPr>
            <a:xfrm>
              <a:off x="217080" y="3459960"/>
              <a:ext cx="1047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cetyl-Co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直接连接符 12"/>
            <p:cNvSpPr/>
            <p:nvPr/>
          </p:nvSpPr>
          <p:spPr>
            <a:xfrm>
              <a:off x="937800" y="3592440"/>
              <a:ext cx="406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Box 13"/>
            <p:cNvSpPr/>
            <p:nvPr/>
          </p:nvSpPr>
          <p:spPr>
            <a:xfrm>
              <a:off x="1266120" y="3469680"/>
              <a:ext cx="1512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3 × malonyl-Co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直接连接符 14"/>
            <p:cNvSpPr/>
            <p:nvPr/>
          </p:nvSpPr>
          <p:spPr>
            <a:xfrm>
              <a:off x="2843280" y="3579480"/>
              <a:ext cx="504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直接连接符 17"/>
            <p:cNvSpPr/>
            <p:nvPr/>
          </p:nvSpPr>
          <p:spPr>
            <a:xfrm flipH="1" flipV="1">
              <a:off x="1571400" y="3114720"/>
              <a:ext cx="1440" cy="4330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直接连接符 18"/>
            <p:cNvSpPr/>
            <p:nvPr/>
          </p:nvSpPr>
          <p:spPr>
            <a:xfrm flipV="1">
              <a:off x="3138480" y="3114720"/>
              <a:ext cx="0" cy="3092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直接连接符 19"/>
            <p:cNvSpPr/>
            <p:nvPr/>
          </p:nvSpPr>
          <p:spPr>
            <a:xfrm flipH="1">
              <a:off x="1559880" y="3119040"/>
              <a:ext cx="1584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直接连接符 25"/>
            <p:cNvSpPr/>
            <p:nvPr/>
          </p:nvSpPr>
          <p:spPr>
            <a:xfrm flipV="1">
              <a:off x="2273040" y="2952720"/>
              <a:ext cx="0" cy="17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Box 59"/>
            <p:cNvSpPr/>
            <p:nvPr/>
          </p:nvSpPr>
          <p:spPr>
            <a:xfrm>
              <a:off x="1620720" y="3113280"/>
              <a:ext cx="64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b050"/>
                  </a:solidFill>
                  <a:latin typeface="Times New Roman"/>
                </a:rPr>
                <a:t>CH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Box 60"/>
            <p:cNvSpPr/>
            <p:nvPr/>
          </p:nvSpPr>
          <p:spPr>
            <a:xfrm>
              <a:off x="3082680" y="3121200"/>
              <a:ext cx="64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TT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Box 61"/>
            <p:cNvSpPr/>
            <p:nvPr/>
          </p:nvSpPr>
          <p:spPr>
            <a:xfrm>
              <a:off x="1787040" y="2768760"/>
              <a:ext cx="137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Naringenin chalcon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Box 62"/>
            <p:cNvSpPr/>
            <p:nvPr/>
          </p:nvSpPr>
          <p:spPr>
            <a:xfrm>
              <a:off x="1899720" y="2487960"/>
              <a:ext cx="84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Naringen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直接连接符 63"/>
            <p:cNvSpPr/>
            <p:nvPr/>
          </p:nvSpPr>
          <p:spPr>
            <a:xfrm flipV="1">
              <a:off x="2236680" y="2658960"/>
              <a:ext cx="0" cy="180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直接连接符 64"/>
            <p:cNvSpPr/>
            <p:nvPr/>
          </p:nvSpPr>
          <p:spPr>
            <a:xfrm>
              <a:off x="2311200" y="2671560"/>
              <a:ext cx="0" cy="180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直接连接符 65"/>
            <p:cNvSpPr/>
            <p:nvPr/>
          </p:nvSpPr>
          <p:spPr>
            <a:xfrm flipV="1">
              <a:off x="2251080" y="2251080"/>
              <a:ext cx="0" cy="288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Box 66"/>
            <p:cNvSpPr/>
            <p:nvPr/>
          </p:nvSpPr>
          <p:spPr>
            <a:xfrm>
              <a:off x="1676160" y="2044800"/>
              <a:ext cx="1189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ihydrokaempfer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Box 69"/>
            <p:cNvSpPr/>
            <p:nvPr/>
          </p:nvSpPr>
          <p:spPr>
            <a:xfrm>
              <a:off x="2279880" y="2646360"/>
              <a:ext cx="64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b050"/>
                  </a:solidFill>
                  <a:latin typeface="Times New Roman"/>
                </a:rPr>
                <a:t>CH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Box 72"/>
            <p:cNvSpPr/>
            <p:nvPr/>
          </p:nvSpPr>
          <p:spPr>
            <a:xfrm>
              <a:off x="1904400" y="2340000"/>
              <a:ext cx="411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TT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Box 74"/>
            <p:cNvSpPr/>
            <p:nvPr/>
          </p:nvSpPr>
          <p:spPr>
            <a:xfrm>
              <a:off x="768600" y="2452320"/>
              <a:ext cx="819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Times New Roman"/>
                </a:rPr>
                <a:t>Flavonols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直接连接符 75"/>
            <p:cNvSpPr/>
            <p:nvPr/>
          </p:nvSpPr>
          <p:spPr>
            <a:xfrm flipH="1">
              <a:off x="1386720" y="2347920"/>
              <a:ext cx="469800" cy="214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Box 70"/>
            <p:cNvSpPr/>
            <p:nvPr/>
          </p:nvSpPr>
          <p:spPr>
            <a:xfrm>
              <a:off x="1166400" y="1950480"/>
              <a:ext cx="1047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85800"/>
                  <a:tab algn="l" pos="1371600"/>
                  <a:tab algn="l" pos="2057400"/>
                  <a:tab algn="l" pos="2743200"/>
                  <a:tab algn="l" pos="3429000"/>
                  <a:tab algn="l" pos="4114800"/>
                  <a:tab algn="l" pos="4800600"/>
                  <a:tab algn="l" pos="5486400"/>
                  <a:tab algn="l" pos="6172200"/>
                  <a:tab algn="l" pos="6858000"/>
                  <a:tab algn="l" pos="7543800"/>
                  <a:tab algn="l" pos="8229600"/>
                  <a:tab algn="l" pos="8915400"/>
                  <a:tab algn="l" pos="9601200"/>
                  <a:tab algn="l" pos="10287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F3’5’H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Box 71"/>
            <p:cNvSpPr/>
            <p:nvPr/>
          </p:nvSpPr>
          <p:spPr>
            <a:xfrm>
              <a:off x="151560" y="2041560"/>
              <a:ext cx="1405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85800"/>
                  <a:tab algn="l" pos="1371600"/>
                  <a:tab algn="l" pos="2057400"/>
                  <a:tab algn="l" pos="2743200"/>
                  <a:tab algn="l" pos="3429000"/>
                  <a:tab algn="l" pos="4114800"/>
                  <a:tab algn="l" pos="4800600"/>
                  <a:tab algn="l" pos="5486400"/>
                  <a:tab algn="l" pos="6172200"/>
                  <a:tab algn="l" pos="6858000"/>
                  <a:tab algn="l" pos="7543800"/>
                  <a:tab algn="l" pos="8229600"/>
                  <a:tab algn="l" pos="8915400"/>
                  <a:tab algn="l" pos="9601200"/>
                  <a:tab algn="l" pos="10287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ihydromyricet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Box 58"/>
            <p:cNvSpPr/>
            <p:nvPr/>
          </p:nvSpPr>
          <p:spPr>
            <a:xfrm>
              <a:off x="142920" y="1412280"/>
              <a:ext cx="1162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85800"/>
                  <a:tab algn="l" pos="1371600"/>
                  <a:tab algn="l" pos="2057400"/>
                  <a:tab algn="l" pos="2743200"/>
                  <a:tab algn="l" pos="3429000"/>
                  <a:tab algn="l" pos="4114800"/>
                  <a:tab algn="l" pos="4800600"/>
                  <a:tab algn="l" pos="5486400"/>
                  <a:tab algn="l" pos="6172200"/>
                  <a:tab algn="l" pos="6858000"/>
                  <a:tab algn="l" pos="7543800"/>
                  <a:tab algn="l" pos="8229600"/>
                  <a:tab algn="l" pos="8915400"/>
                  <a:tab algn="l" pos="9601200"/>
                  <a:tab algn="l" pos="10287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Leucodelphinid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Box 85"/>
            <p:cNvSpPr/>
            <p:nvPr/>
          </p:nvSpPr>
          <p:spPr>
            <a:xfrm>
              <a:off x="1364760" y="2193840"/>
              <a:ext cx="430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0000"/>
                  </a:solidFill>
                  <a:latin typeface="Times New Roman"/>
                </a:rPr>
                <a:t>F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直接连接符 88"/>
            <p:cNvSpPr/>
            <p:nvPr/>
          </p:nvSpPr>
          <p:spPr>
            <a:xfrm>
              <a:off x="2803320" y="2199960"/>
              <a:ext cx="541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直接连接符 89"/>
            <p:cNvSpPr/>
            <p:nvPr/>
          </p:nvSpPr>
          <p:spPr>
            <a:xfrm flipH="1">
              <a:off x="1217160" y="2180880"/>
              <a:ext cx="431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Box 71"/>
            <p:cNvSpPr/>
            <p:nvPr/>
          </p:nvSpPr>
          <p:spPr>
            <a:xfrm>
              <a:off x="3373200" y="2058480"/>
              <a:ext cx="1405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85800"/>
                  <a:tab algn="l" pos="1371600"/>
                  <a:tab algn="l" pos="2057400"/>
                  <a:tab algn="l" pos="2743200"/>
                  <a:tab algn="l" pos="3429000"/>
                  <a:tab algn="l" pos="4114800"/>
                  <a:tab algn="l" pos="4800600"/>
                  <a:tab algn="l" pos="5486400"/>
                  <a:tab algn="l" pos="6172200"/>
                  <a:tab algn="l" pos="6858000"/>
                  <a:tab algn="l" pos="7543800"/>
                  <a:tab algn="l" pos="8229600"/>
                  <a:tab algn="l" pos="8915400"/>
                  <a:tab algn="l" pos="9601200"/>
                  <a:tab algn="l" pos="10287000"/>
                </a:tabLst>
              </a:pPr>
              <a:r>
                <a:rPr b="0" lang="en-US" sz="1000" spc="-1" strike="noStrike">
                  <a:solidFill>
                    <a:srgbClr val="00b050"/>
                  </a:solidFill>
                  <a:latin typeface="Times New Roman"/>
                </a:rPr>
                <a:t>Dihydroquercet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直接连接符 93"/>
            <p:cNvSpPr/>
            <p:nvPr/>
          </p:nvSpPr>
          <p:spPr>
            <a:xfrm flipV="1">
              <a:off x="2241360" y="1644480"/>
              <a:ext cx="0" cy="431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直接连接符 94"/>
            <p:cNvSpPr/>
            <p:nvPr/>
          </p:nvSpPr>
          <p:spPr>
            <a:xfrm flipV="1">
              <a:off x="3929040" y="1650960"/>
              <a:ext cx="0" cy="431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Box 70"/>
            <p:cNvSpPr/>
            <p:nvPr/>
          </p:nvSpPr>
          <p:spPr>
            <a:xfrm>
              <a:off x="2838240" y="1976040"/>
              <a:ext cx="1047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85800"/>
                  <a:tab algn="l" pos="1371600"/>
                  <a:tab algn="l" pos="2057400"/>
                  <a:tab algn="l" pos="2743200"/>
                  <a:tab algn="l" pos="3429000"/>
                  <a:tab algn="l" pos="4114800"/>
                  <a:tab algn="l" pos="4800600"/>
                  <a:tab algn="l" pos="5486400"/>
                  <a:tab algn="l" pos="6172200"/>
                  <a:tab algn="l" pos="6858000"/>
                  <a:tab algn="l" pos="7543800"/>
                  <a:tab algn="l" pos="8229600"/>
                  <a:tab algn="l" pos="8915400"/>
                  <a:tab algn="l" pos="9601200"/>
                  <a:tab algn="l" pos="10287000"/>
                </a:tabLst>
              </a:pPr>
              <a:r>
                <a:rPr b="0" lang="en-US" sz="1000" spc="-1" strike="noStrike">
                  <a:solidFill>
                    <a:srgbClr val="00b050"/>
                  </a:solidFill>
                  <a:latin typeface="Times New Roman"/>
                </a:rPr>
                <a:t>F3’H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直接连接符 97"/>
            <p:cNvSpPr/>
            <p:nvPr/>
          </p:nvSpPr>
          <p:spPr>
            <a:xfrm flipV="1">
              <a:off x="695160" y="1626840"/>
              <a:ext cx="0" cy="431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Box 98"/>
            <p:cNvSpPr/>
            <p:nvPr/>
          </p:nvSpPr>
          <p:spPr>
            <a:xfrm>
              <a:off x="3668760" y="1419120"/>
              <a:ext cx="107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leucocyanid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Box 99"/>
            <p:cNvSpPr/>
            <p:nvPr/>
          </p:nvSpPr>
          <p:spPr>
            <a:xfrm>
              <a:off x="1760400" y="1427760"/>
              <a:ext cx="1149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leucopelargonid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直接连接符 101"/>
            <p:cNvSpPr/>
            <p:nvPr/>
          </p:nvSpPr>
          <p:spPr>
            <a:xfrm flipV="1">
              <a:off x="691920" y="1271160"/>
              <a:ext cx="0" cy="17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直接连接符 102"/>
            <p:cNvSpPr/>
            <p:nvPr/>
          </p:nvSpPr>
          <p:spPr>
            <a:xfrm flipV="1">
              <a:off x="2216160" y="1263240"/>
              <a:ext cx="0" cy="17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直接连接符 103"/>
            <p:cNvSpPr/>
            <p:nvPr/>
          </p:nvSpPr>
          <p:spPr>
            <a:xfrm flipV="1">
              <a:off x="3913200" y="1269720"/>
              <a:ext cx="0" cy="17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TextBox 105"/>
            <p:cNvSpPr/>
            <p:nvPr/>
          </p:nvSpPr>
          <p:spPr>
            <a:xfrm>
              <a:off x="3541680" y="1079280"/>
              <a:ext cx="107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b050"/>
                  </a:solidFill>
                  <a:latin typeface="Times New Roman"/>
                </a:rPr>
                <a:t>Cyanid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Box 106"/>
            <p:cNvSpPr/>
            <p:nvPr/>
          </p:nvSpPr>
          <p:spPr>
            <a:xfrm>
              <a:off x="1818000" y="1068120"/>
              <a:ext cx="107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b050"/>
                  </a:solidFill>
                  <a:latin typeface="Times New Roman"/>
                </a:rPr>
                <a:t>Pelargonid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Box 107"/>
            <p:cNvSpPr/>
            <p:nvPr/>
          </p:nvSpPr>
          <p:spPr>
            <a:xfrm>
              <a:off x="277920" y="1061640"/>
              <a:ext cx="107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elphinid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Box 108"/>
            <p:cNvSpPr/>
            <p:nvPr/>
          </p:nvSpPr>
          <p:spPr>
            <a:xfrm>
              <a:off x="648360" y="1725840"/>
              <a:ext cx="64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b050"/>
                  </a:solidFill>
                  <a:latin typeface="Times New Roman"/>
                </a:rPr>
                <a:t>DR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Box 111"/>
            <p:cNvSpPr/>
            <p:nvPr/>
          </p:nvSpPr>
          <p:spPr>
            <a:xfrm>
              <a:off x="3892680" y="1736640"/>
              <a:ext cx="64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b050"/>
                  </a:solidFill>
                  <a:latin typeface="Times New Roman"/>
                </a:rPr>
                <a:t>DR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Box 114"/>
            <p:cNvSpPr/>
            <p:nvPr/>
          </p:nvSpPr>
          <p:spPr>
            <a:xfrm>
              <a:off x="3881520" y="1231560"/>
              <a:ext cx="547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直接连接符 116"/>
            <p:cNvSpPr/>
            <p:nvPr/>
          </p:nvSpPr>
          <p:spPr>
            <a:xfrm flipH="1" flipV="1">
              <a:off x="668160" y="926640"/>
              <a:ext cx="1440" cy="17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直接连接符 117"/>
            <p:cNvSpPr/>
            <p:nvPr/>
          </p:nvSpPr>
          <p:spPr>
            <a:xfrm flipH="1" flipV="1">
              <a:off x="2217600" y="933120"/>
              <a:ext cx="1440" cy="17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直接连接符 118"/>
            <p:cNvSpPr/>
            <p:nvPr/>
          </p:nvSpPr>
          <p:spPr>
            <a:xfrm flipH="1" flipV="1">
              <a:off x="3782880" y="928440"/>
              <a:ext cx="1440" cy="1792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直接连接符 119"/>
            <p:cNvSpPr/>
            <p:nvPr/>
          </p:nvSpPr>
          <p:spPr>
            <a:xfrm flipH="1">
              <a:off x="653400" y="929880"/>
              <a:ext cx="31323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直接连接符 121"/>
            <p:cNvSpPr/>
            <p:nvPr/>
          </p:nvSpPr>
          <p:spPr>
            <a:xfrm flipV="1">
              <a:off x="2224080" y="575640"/>
              <a:ext cx="0" cy="360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直接连接符 127"/>
            <p:cNvSpPr/>
            <p:nvPr/>
          </p:nvSpPr>
          <p:spPr>
            <a:xfrm flipV="1">
              <a:off x="4292640" y="463320"/>
              <a:ext cx="0" cy="1008000"/>
            </a:xfrm>
            <a:prstGeom prst="line">
              <a:avLst/>
            </a:prstGeom>
            <a:ln w="19080">
              <a:solidFill>
                <a:srgbClr val="000000"/>
              </a:solidFill>
              <a:prstDash val="sys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Box 129"/>
            <p:cNvSpPr/>
            <p:nvPr/>
          </p:nvSpPr>
          <p:spPr>
            <a:xfrm>
              <a:off x="3149640" y="471240"/>
              <a:ext cx="107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(+)-Epicatech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直接连接符 130"/>
            <p:cNvSpPr/>
            <p:nvPr/>
          </p:nvSpPr>
          <p:spPr>
            <a:xfrm flipV="1">
              <a:off x="3963960" y="663120"/>
              <a:ext cx="0" cy="431640"/>
            </a:xfrm>
            <a:prstGeom prst="line">
              <a:avLst/>
            </a:prstGeom>
            <a:ln w="19080">
              <a:solidFill>
                <a:srgbClr val="000000"/>
              </a:solidFill>
              <a:prstDash val="sysDash"/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TextBox 131"/>
            <p:cNvSpPr/>
            <p:nvPr/>
          </p:nvSpPr>
          <p:spPr>
            <a:xfrm>
              <a:off x="3645360" y="300600"/>
              <a:ext cx="107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(+)-Epicatech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TextBox 132"/>
            <p:cNvSpPr/>
            <p:nvPr/>
          </p:nvSpPr>
          <p:spPr>
            <a:xfrm>
              <a:off x="3894120" y="798480"/>
              <a:ext cx="642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N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直接连接符 133"/>
            <p:cNvSpPr/>
            <p:nvPr/>
          </p:nvSpPr>
          <p:spPr>
            <a:xfrm flipH="1" flipV="1">
              <a:off x="3500280" y="232920"/>
              <a:ext cx="1440" cy="287280"/>
            </a:xfrm>
            <a:prstGeom prst="line">
              <a:avLst/>
            </a:prstGeom>
            <a:ln w="936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直接连接符 134"/>
            <p:cNvSpPr/>
            <p:nvPr/>
          </p:nvSpPr>
          <p:spPr>
            <a:xfrm flipH="1" flipV="1">
              <a:off x="4084560" y="234360"/>
              <a:ext cx="1440" cy="109440"/>
            </a:xfrm>
            <a:prstGeom prst="line">
              <a:avLst/>
            </a:prstGeom>
            <a:ln w="936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直接连接符 135"/>
            <p:cNvSpPr/>
            <p:nvPr/>
          </p:nvSpPr>
          <p:spPr>
            <a:xfrm flipH="1">
              <a:off x="3505320" y="240840"/>
              <a:ext cx="57600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Box 136"/>
            <p:cNvSpPr/>
            <p:nvPr/>
          </p:nvSpPr>
          <p:spPr>
            <a:xfrm>
              <a:off x="3636000" y="756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b050"/>
                  </a:solidFill>
                  <a:latin typeface="Times New Roman"/>
                </a:rPr>
                <a:t>PA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0" name="直接连接符 235"/>
          <p:cNvSpPr/>
          <p:nvPr/>
        </p:nvSpPr>
        <p:spPr>
          <a:xfrm>
            <a:off x="1995480" y="4437000"/>
            <a:ext cx="40644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Box 149"/>
          <p:cNvSpPr/>
          <p:nvPr/>
        </p:nvSpPr>
        <p:spPr>
          <a:xfrm>
            <a:off x="920880" y="4273560"/>
            <a:ext cx="92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0000"/>
                </a:solidFill>
                <a:latin typeface="Times New Roman"/>
              </a:rPr>
              <a:t>Glycoly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2" name="组合 245"/>
          <p:cNvGrpSpPr/>
          <p:nvPr/>
        </p:nvGrpSpPr>
        <p:grpSpPr>
          <a:xfrm>
            <a:off x="23760" y="4840200"/>
            <a:ext cx="4645080" cy="2811600"/>
            <a:chOff x="23760" y="4840200"/>
            <a:chExt cx="4645080" cy="2811600"/>
          </a:xfrm>
        </p:grpSpPr>
        <p:grpSp>
          <p:nvGrpSpPr>
            <p:cNvPr id="163" name="组合 234"/>
            <p:cNvGrpSpPr/>
            <p:nvPr/>
          </p:nvGrpSpPr>
          <p:grpSpPr>
            <a:xfrm>
              <a:off x="23760" y="4840200"/>
              <a:ext cx="4645080" cy="2811600"/>
              <a:chOff x="23760" y="4840200"/>
              <a:chExt cx="4645080" cy="2811600"/>
            </a:xfrm>
          </p:grpSpPr>
          <p:sp>
            <p:nvSpPr>
              <p:cNvPr id="164" name="圆角矩形 4"/>
              <p:cNvSpPr/>
              <p:nvPr/>
            </p:nvSpPr>
            <p:spPr>
              <a:xfrm>
                <a:off x="68040" y="5034600"/>
                <a:ext cx="4457880" cy="2617200"/>
              </a:xfrm>
              <a:prstGeom prst="roundRect">
                <a:avLst>
                  <a:gd name="adj" fmla="val 16667"/>
                </a:avLst>
              </a:prstGeom>
              <a:noFill/>
              <a:ln w="158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TextBox 205"/>
              <p:cNvSpPr/>
              <p:nvPr/>
            </p:nvSpPr>
            <p:spPr>
              <a:xfrm>
                <a:off x="833400" y="6345360"/>
                <a:ext cx="692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Times New Roman"/>
                  </a:rPr>
                  <a:t>NAOA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文本框 327"/>
              <p:cNvSpPr/>
              <p:nvPr/>
            </p:nvSpPr>
            <p:spPr>
              <a:xfrm>
                <a:off x="2574000" y="6170040"/>
                <a:ext cx="1133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α-ketoglutarat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TextBox 168"/>
              <p:cNvSpPr/>
              <p:nvPr/>
            </p:nvSpPr>
            <p:spPr>
              <a:xfrm>
                <a:off x="2493000" y="5605200"/>
                <a:ext cx="1039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 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Glutamine 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矩形 171"/>
              <p:cNvSpPr/>
              <p:nvPr/>
            </p:nvSpPr>
            <p:spPr>
              <a:xfrm>
                <a:off x="1968840" y="5598360"/>
                <a:ext cx="709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Glutamat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直接连接符 172"/>
              <p:cNvSpPr/>
              <p:nvPr/>
            </p:nvSpPr>
            <p:spPr>
              <a:xfrm flipH="1" flipV="1">
                <a:off x="3465720" y="5450040"/>
                <a:ext cx="69840" cy="1038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TextBox 174"/>
              <p:cNvSpPr/>
              <p:nvPr/>
            </p:nvSpPr>
            <p:spPr>
              <a:xfrm>
                <a:off x="3124080" y="5245920"/>
                <a:ext cx="692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GSA/P5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直接连接符 175"/>
              <p:cNvSpPr/>
              <p:nvPr/>
            </p:nvSpPr>
            <p:spPr>
              <a:xfrm>
                <a:off x="3733920" y="5333040"/>
                <a:ext cx="39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TextBox 176"/>
              <p:cNvSpPr/>
              <p:nvPr/>
            </p:nvSpPr>
            <p:spPr>
              <a:xfrm rot="15696000">
                <a:off x="3186360" y="5823360"/>
                <a:ext cx="775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Times New Roman"/>
                  </a:rPr>
                  <a:t>P5C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TextBox 177"/>
              <p:cNvSpPr/>
              <p:nvPr/>
            </p:nvSpPr>
            <p:spPr>
              <a:xfrm>
                <a:off x="4045320" y="5235120"/>
                <a:ext cx="623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Times New Roman"/>
                  </a:rPr>
                  <a:t>Prolin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TextBox 179"/>
              <p:cNvSpPr/>
              <p:nvPr/>
            </p:nvSpPr>
            <p:spPr>
              <a:xfrm>
                <a:off x="3667680" y="5117040"/>
                <a:ext cx="554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Times New Roman"/>
                  </a:rPr>
                  <a:t>P5C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直接连接符 180"/>
              <p:cNvSpPr/>
              <p:nvPr/>
            </p:nvSpPr>
            <p:spPr>
              <a:xfrm>
                <a:off x="2163600" y="7383600"/>
                <a:ext cx="3952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TextBox 182"/>
              <p:cNvSpPr/>
              <p:nvPr/>
            </p:nvSpPr>
            <p:spPr>
              <a:xfrm>
                <a:off x="2473200" y="7244640"/>
                <a:ext cx="1247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Ornithin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直接连接符 183"/>
              <p:cNvSpPr/>
              <p:nvPr/>
            </p:nvSpPr>
            <p:spPr>
              <a:xfrm>
                <a:off x="3014640" y="7385040"/>
                <a:ext cx="5760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TextBox 185"/>
              <p:cNvSpPr/>
              <p:nvPr/>
            </p:nvSpPr>
            <p:spPr>
              <a:xfrm>
                <a:off x="3512160" y="7254360"/>
                <a:ext cx="654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Times New Roman"/>
                  </a:rPr>
                  <a:t>Arginin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TextBox 188"/>
              <p:cNvSpPr/>
              <p:nvPr/>
            </p:nvSpPr>
            <p:spPr>
              <a:xfrm rot="16200000">
                <a:off x="2887920" y="7000560"/>
                <a:ext cx="500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OT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TextBox 189"/>
              <p:cNvSpPr/>
              <p:nvPr/>
            </p:nvSpPr>
            <p:spPr>
              <a:xfrm rot="16200000">
                <a:off x="3031560" y="7000920"/>
                <a:ext cx="509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Times New Roman"/>
                  </a:rPr>
                  <a:t>ASSY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TextBox 190"/>
              <p:cNvSpPr/>
              <p:nvPr/>
            </p:nvSpPr>
            <p:spPr>
              <a:xfrm rot="16200000">
                <a:off x="3220920" y="7039080"/>
                <a:ext cx="434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Times New Roman"/>
                  </a:rPr>
                  <a:t>AS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TextBox 191"/>
              <p:cNvSpPr/>
              <p:nvPr/>
            </p:nvSpPr>
            <p:spPr>
              <a:xfrm>
                <a:off x="2402280" y="6639480"/>
                <a:ext cx="830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Times New Roman"/>
                  </a:rPr>
                  <a:t>NAOA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直接连接符 192"/>
              <p:cNvSpPr/>
              <p:nvPr/>
            </p:nvSpPr>
            <p:spPr>
              <a:xfrm flipH="1">
                <a:off x="3715920" y="5409360"/>
                <a:ext cx="3934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TextBox 194"/>
              <p:cNvSpPr/>
              <p:nvPr/>
            </p:nvSpPr>
            <p:spPr>
              <a:xfrm>
                <a:off x="2349360" y="5484960"/>
                <a:ext cx="554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Times New Roman"/>
                  </a:rPr>
                  <a:t>GS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矩形 195"/>
              <p:cNvSpPr/>
              <p:nvPr/>
            </p:nvSpPr>
            <p:spPr>
              <a:xfrm>
                <a:off x="1747440" y="6162120"/>
                <a:ext cx="709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Glutamat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TextBox 197"/>
              <p:cNvSpPr/>
              <p:nvPr/>
            </p:nvSpPr>
            <p:spPr>
              <a:xfrm>
                <a:off x="2239920" y="5977080"/>
                <a:ext cx="793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Times New Roman"/>
                  </a:rPr>
                  <a:t>GOGA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直接连接符 199"/>
              <p:cNvSpPr/>
              <p:nvPr/>
            </p:nvSpPr>
            <p:spPr>
              <a:xfrm flipH="1" flipV="1">
                <a:off x="861480" y="6298560"/>
                <a:ext cx="934920" cy="14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直接连接符 201"/>
              <p:cNvSpPr/>
              <p:nvPr/>
            </p:nvSpPr>
            <p:spPr>
              <a:xfrm>
                <a:off x="857160" y="6293880"/>
                <a:ext cx="0" cy="10083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TextBox 203"/>
              <p:cNvSpPr/>
              <p:nvPr/>
            </p:nvSpPr>
            <p:spPr>
              <a:xfrm>
                <a:off x="277560" y="7242480"/>
                <a:ext cx="2035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N-acetylglutamate-5-semialdehyd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TextBox 206"/>
              <p:cNvSpPr/>
              <p:nvPr/>
            </p:nvSpPr>
            <p:spPr>
              <a:xfrm>
                <a:off x="835920" y="6513840"/>
                <a:ext cx="791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NAOGAc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TextBox 208"/>
              <p:cNvSpPr/>
              <p:nvPr/>
            </p:nvSpPr>
            <p:spPr>
              <a:xfrm>
                <a:off x="841680" y="6702120"/>
                <a:ext cx="791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NAGK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TextBox 209"/>
              <p:cNvSpPr/>
              <p:nvPr/>
            </p:nvSpPr>
            <p:spPr>
              <a:xfrm>
                <a:off x="833040" y="6877080"/>
                <a:ext cx="701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NAGP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直接连接符 217"/>
              <p:cNvSpPr/>
              <p:nvPr/>
            </p:nvSpPr>
            <p:spPr>
              <a:xfrm>
                <a:off x="2268360" y="6368760"/>
                <a:ext cx="0" cy="10083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TextBox 221"/>
              <p:cNvSpPr/>
              <p:nvPr/>
            </p:nvSpPr>
            <p:spPr>
              <a:xfrm>
                <a:off x="2408400" y="6787800"/>
                <a:ext cx="830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Times New Roman"/>
                  </a:rPr>
                  <a:t>NAO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TextBox 222"/>
              <p:cNvSpPr/>
              <p:nvPr/>
            </p:nvSpPr>
            <p:spPr>
              <a:xfrm>
                <a:off x="23760" y="5936760"/>
                <a:ext cx="900720" cy="703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ff0000"/>
                    </a:solidFill>
                    <a:latin typeface="Times New Roman"/>
                  </a:rPr>
                  <a:t>Sugar and glutamate amino acids synthesis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直接连接符 224"/>
              <p:cNvSpPr/>
              <p:nvPr/>
            </p:nvSpPr>
            <p:spPr>
              <a:xfrm>
                <a:off x="2462040" y="6285960"/>
                <a:ext cx="795240" cy="411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直接连接符 227"/>
              <p:cNvSpPr/>
              <p:nvPr/>
            </p:nvSpPr>
            <p:spPr>
              <a:xfrm flipV="1">
                <a:off x="3257640" y="6489000"/>
                <a:ext cx="277560" cy="207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直接连接符 231"/>
              <p:cNvSpPr/>
              <p:nvPr/>
            </p:nvSpPr>
            <p:spPr>
              <a:xfrm>
                <a:off x="3056760" y="4840200"/>
                <a:ext cx="176040" cy="12657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9" name="直接连接符 238"/>
            <p:cNvSpPr/>
            <p:nvPr/>
          </p:nvSpPr>
          <p:spPr>
            <a:xfrm flipV="1">
              <a:off x="2284560" y="5373360"/>
              <a:ext cx="1440" cy="1666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直接连接符 242"/>
            <p:cNvSpPr/>
            <p:nvPr/>
          </p:nvSpPr>
          <p:spPr>
            <a:xfrm flipH="1">
              <a:off x="2281320" y="5376960"/>
              <a:ext cx="576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1" name="直接连接符 244"/>
          <p:cNvSpPr/>
          <p:nvPr/>
        </p:nvSpPr>
        <p:spPr>
          <a:xfrm>
            <a:off x="2849400" y="5513400"/>
            <a:ext cx="0" cy="17928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直接连接符 246"/>
          <p:cNvSpPr/>
          <p:nvPr/>
        </p:nvSpPr>
        <p:spPr>
          <a:xfrm flipV="1">
            <a:off x="2855160" y="5824080"/>
            <a:ext cx="1800" cy="166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直接连接符 247"/>
          <p:cNvSpPr/>
          <p:nvPr/>
        </p:nvSpPr>
        <p:spPr>
          <a:xfrm flipH="1">
            <a:off x="2273400" y="5987880"/>
            <a:ext cx="576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直接连接符 248"/>
          <p:cNvSpPr/>
          <p:nvPr/>
        </p:nvSpPr>
        <p:spPr>
          <a:xfrm flipV="1">
            <a:off x="2273400" y="5808240"/>
            <a:ext cx="0" cy="18108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直接连接符 249"/>
          <p:cNvSpPr/>
          <p:nvPr/>
        </p:nvSpPr>
        <p:spPr>
          <a:xfrm flipV="1">
            <a:off x="2273400" y="5981400"/>
            <a:ext cx="1440" cy="1666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直接连接符 250"/>
          <p:cNvSpPr/>
          <p:nvPr/>
        </p:nvSpPr>
        <p:spPr>
          <a:xfrm>
            <a:off x="2852640" y="5987160"/>
            <a:ext cx="0" cy="18108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弧形 252"/>
          <p:cNvSpPr/>
          <p:nvPr/>
        </p:nvSpPr>
        <p:spPr>
          <a:xfrm>
            <a:off x="646200" y="3708360"/>
            <a:ext cx="1295280" cy="1295280"/>
          </a:xfrm>
          <a:custGeom>
            <a:avLst/>
            <a:gdLst/>
            <a:ahLst/>
            <a:rect l="l" t="t" r="r" b="b"/>
            <a:pathLst>
              <a:path stroke="0" w="1295400" h="1295400">
                <a:moveTo>
                  <a:pt x="647700" y="0"/>
                </a:moveTo>
                <a:cubicBezTo>
                  <a:pt x="979541" y="0"/>
                  <a:pt x="1257703" y="250800"/>
                  <a:pt x="1291943" y="580870"/>
                </a:cubicBezTo>
                <a:cubicBezTo>
                  <a:pt x="1326183" y="910940"/>
                  <a:pt x="1105422" y="1213495"/>
                  <a:pt x="780647" y="1281609"/>
                </a:cubicBezTo>
                <a:cubicBezTo>
                  <a:pt x="455872" y="1349723"/>
                  <a:pt x="132153" y="1161358"/>
                  <a:pt x="30892" y="845345"/>
                </a:cubicBezTo>
                <a:cubicBezTo>
                  <a:pt x="-70369" y="529332"/>
                  <a:pt x="83588" y="187905"/>
                  <a:pt x="387467" y="54578"/>
                </a:cubicBezTo>
                <a:lnTo>
                  <a:pt x="647700" y="647700"/>
                </a:lnTo>
                <a:lnTo>
                  <a:pt x="647700" y="0"/>
                </a:lnTo>
                <a:close/>
              </a:path>
              <a:path fill="none" w="1295400" h="1295400">
                <a:moveTo>
                  <a:pt x="647700" y="0"/>
                </a:moveTo>
                <a:cubicBezTo>
                  <a:pt x="979541" y="0"/>
                  <a:pt x="1257703" y="250800"/>
                  <a:pt x="1291943" y="580870"/>
                </a:cubicBezTo>
                <a:cubicBezTo>
                  <a:pt x="1326183" y="910940"/>
                  <a:pt x="1105422" y="1213495"/>
                  <a:pt x="780647" y="1281609"/>
                </a:cubicBezTo>
                <a:cubicBezTo>
                  <a:pt x="455872" y="1349723"/>
                  <a:pt x="132153" y="1161358"/>
                  <a:pt x="30892" y="845345"/>
                </a:cubicBezTo>
                <a:cubicBezTo>
                  <a:pt x="-70369" y="529332"/>
                  <a:pt x="83588" y="187905"/>
                  <a:pt x="387467" y="54578"/>
                </a:cubicBezTo>
              </a:path>
            </a:pathLst>
          </a:custGeom>
          <a:noFill/>
          <a:ln w="9360">
            <a:solidFill>
              <a:srgbClr val="ff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Box 137"/>
          <p:cNvSpPr/>
          <p:nvPr/>
        </p:nvSpPr>
        <p:spPr>
          <a:xfrm>
            <a:off x="4222800" y="976320"/>
            <a:ext cx="64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LA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Box 22"/>
          <p:cNvSpPr/>
          <p:nvPr/>
        </p:nvSpPr>
        <p:spPr>
          <a:xfrm>
            <a:off x="2808360" y="3357720"/>
            <a:ext cx="257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p-Coumaroyl-Co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直接连接符 255"/>
          <p:cNvSpPr/>
          <p:nvPr/>
        </p:nvSpPr>
        <p:spPr>
          <a:xfrm flipH="1" flipV="1">
            <a:off x="626760" y="3630600"/>
            <a:ext cx="314280" cy="1778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直接连接符 258"/>
          <p:cNvSpPr/>
          <p:nvPr/>
        </p:nvSpPr>
        <p:spPr>
          <a:xfrm>
            <a:off x="2357280" y="3579840"/>
            <a:ext cx="40644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直接连接符 259"/>
          <p:cNvSpPr/>
          <p:nvPr/>
        </p:nvSpPr>
        <p:spPr>
          <a:xfrm>
            <a:off x="3400560" y="3579840"/>
            <a:ext cx="50328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直接连接符 260"/>
          <p:cNvSpPr/>
          <p:nvPr/>
        </p:nvSpPr>
        <p:spPr>
          <a:xfrm>
            <a:off x="3933720" y="3584520"/>
            <a:ext cx="50328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直接连接符 261"/>
          <p:cNvSpPr/>
          <p:nvPr/>
        </p:nvSpPr>
        <p:spPr>
          <a:xfrm>
            <a:off x="4428360" y="3651120"/>
            <a:ext cx="428760" cy="194472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直接连接符 271"/>
          <p:cNvSpPr/>
          <p:nvPr/>
        </p:nvSpPr>
        <p:spPr>
          <a:xfrm flipV="1">
            <a:off x="3826800" y="6508440"/>
            <a:ext cx="173160" cy="81756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直接连接符 274"/>
          <p:cNvSpPr/>
          <p:nvPr/>
        </p:nvSpPr>
        <p:spPr>
          <a:xfrm>
            <a:off x="928800" y="3651120"/>
            <a:ext cx="3357360" cy="14292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直接连接符 277"/>
          <p:cNvSpPr/>
          <p:nvPr/>
        </p:nvSpPr>
        <p:spPr>
          <a:xfrm>
            <a:off x="4285440" y="4079880"/>
            <a:ext cx="500040" cy="207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Box 22"/>
          <p:cNvSpPr/>
          <p:nvPr/>
        </p:nvSpPr>
        <p:spPr>
          <a:xfrm>
            <a:off x="4092480" y="3878280"/>
            <a:ext cx="500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IP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Box 281"/>
          <p:cNvSpPr/>
          <p:nvPr/>
        </p:nvSpPr>
        <p:spPr>
          <a:xfrm>
            <a:off x="4748040" y="6041880"/>
            <a:ext cx="64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GP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直接连接符 282"/>
          <p:cNvSpPr/>
          <p:nvPr/>
        </p:nvSpPr>
        <p:spPr>
          <a:xfrm>
            <a:off x="5008680" y="6222960"/>
            <a:ext cx="0" cy="2160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Box 283"/>
          <p:cNvSpPr/>
          <p:nvPr/>
        </p:nvSpPr>
        <p:spPr>
          <a:xfrm>
            <a:off x="5072040" y="6218280"/>
            <a:ext cx="571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P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Box 285"/>
          <p:cNvSpPr/>
          <p:nvPr/>
        </p:nvSpPr>
        <p:spPr>
          <a:xfrm>
            <a:off x="4803840" y="6372360"/>
            <a:ext cx="64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D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直接连接符 286"/>
          <p:cNvSpPr/>
          <p:nvPr/>
        </p:nvSpPr>
        <p:spPr>
          <a:xfrm>
            <a:off x="5013360" y="6546960"/>
            <a:ext cx="0" cy="2156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Box 287"/>
          <p:cNvSpPr/>
          <p:nvPr/>
        </p:nvSpPr>
        <p:spPr>
          <a:xfrm>
            <a:off x="5079960" y="6510240"/>
            <a:ext cx="571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K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TextBox 288"/>
          <p:cNvSpPr/>
          <p:nvPr/>
        </p:nvSpPr>
        <p:spPr>
          <a:xfrm>
            <a:off x="4702320" y="6689880"/>
            <a:ext cx="857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ent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kaure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直接连接符 289"/>
          <p:cNvSpPr/>
          <p:nvPr/>
        </p:nvSpPr>
        <p:spPr>
          <a:xfrm>
            <a:off x="5025960" y="6878520"/>
            <a:ext cx="0" cy="2160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Box 290"/>
          <p:cNvSpPr/>
          <p:nvPr/>
        </p:nvSpPr>
        <p:spPr>
          <a:xfrm>
            <a:off x="4597560" y="7005600"/>
            <a:ext cx="120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ent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-kaurenoic aci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TextBox 291"/>
          <p:cNvSpPr/>
          <p:nvPr/>
        </p:nvSpPr>
        <p:spPr>
          <a:xfrm>
            <a:off x="5076720" y="6834240"/>
            <a:ext cx="571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K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直接连接符 292"/>
          <p:cNvSpPr/>
          <p:nvPr/>
        </p:nvSpPr>
        <p:spPr>
          <a:xfrm>
            <a:off x="5029200" y="7184880"/>
            <a:ext cx="0" cy="2160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Box 293"/>
          <p:cNvSpPr/>
          <p:nvPr/>
        </p:nvSpPr>
        <p:spPr>
          <a:xfrm>
            <a:off x="5051520" y="7159680"/>
            <a:ext cx="571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KA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TextBox 294"/>
          <p:cNvSpPr/>
          <p:nvPr/>
        </p:nvSpPr>
        <p:spPr>
          <a:xfrm>
            <a:off x="4592520" y="7332840"/>
            <a:ext cx="120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12-aidehyd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直接连接符 295"/>
          <p:cNvSpPr/>
          <p:nvPr/>
        </p:nvSpPr>
        <p:spPr>
          <a:xfrm>
            <a:off x="5033880" y="7513560"/>
            <a:ext cx="0" cy="2160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TextBox 296"/>
          <p:cNvSpPr/>
          <p:nvPr/>
        </p:nvSpPr>
        <p:spPr>
          <a:xfrm>
            <a:off x="5064120" y="7504200"/>
            <a:ext cx="571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KA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TextBox 297"/>
          <p:cNvSpPr/>
          <p:nvPr/>
        </p:nvSpPr>
        <p:spPr>
          <a:xfrm>
            <a:off x="4786200" y="7682040"/>
            <a:ext cx="120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直接连接符 298"/>
          <p:cNvSpPr/>
          <p:nvPr/>
        </p:nvSpPr>
        <p:spPr>
          <a:xfrm>
            <a:off x="5041800" y="7854840"/>
            <a:ext cx="0" cy="2160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TextBox 299"/>
          <p:cNvSpPr/>
          <p:nvPr/>
        </p:nvSpPr>
        <p:spPr>
          <a:xfrm>
            <a:off x="4807080" y="7989840"/>
            <a:ext cx="120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直接连接符 300"/>
          <p:cNvSpPr/>
          <p:nvPr/>
        </p:nvSpPr>
        <p:spPr>
          <a:xfrm>
            <a:off x="5038560" y="8163000"/>
            <a:ext cx="0" cy="2160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Box 301"/>
          <p:cNvSpPr/>
          <p:nvPr/>
        </p:nvSpPr>
        <p:spPr>
          <a:xfrm>
            <a:off x="4786200" y="8313840"/>
            <a:ext cx="120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2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直接连接符 345"/>
          <p:cNvSpPr/>
          <p:nvPr/>
        </p:nvSpPr>
        <p:spPr>
          <a:xfrm>
            <a:off x="5219640" y="7812000"/>
            <a:ext cx="68436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Box 346"/>
          <p:cNvSpPr/>
          <p:nvPr/>
        </p:nvSpPr>
        <p:spPr>
          <a:xfrm>
            <a:off x="5857920" y="7677000"/>
            <a:ext cx="120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5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直接连接符 347"/>
          <p:cNvSpPr/>
          <p:nvPr/>
        </p:nvSpPr>
        <p:spPr>
          <a:xfrm>
            <a:off x="5213520" y="8445600"/>
            <a:ext cx="21564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Box 348"/>
          <p:cNvSpPr/>
          <p:nvPr/>
        </p:nvSpPr>
        <p:spPr>
          <a:xfrm>
            <a:off x="5357880" y="8305920"/>
            <a:ext cx="120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TextBox 349"/>
          <p:cNvSpPr/>
          <p:nvPr/>
        </p:nvSpPr>
        <p:spPr>
          <a:xfrm>
            <a:off x="5803920" y="8302680"/>
            <a:ext cx="120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直接连接符 350"/>
          <p:cNvSpPr/>
          <p:nvPr/>
        </p:nvSpPr>
        <p:spPr>
          <a:xfrm>
            <a:off x="5692680" y="8429760"/>
            <a:ext cx="21600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TextBox 351"/>
          <p:cNvSpPr/>
          <p:nvPr/>
        </p:nvSpPr>
        <p:spPr>
          <a:xfrm>
            <a:off x="6261120" y="8299440"/>
            <a:ext cx="120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3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直接连接符 352"/>
          <p:cNvSpPr/>
          <p:nvPr/>
        </p:nvSpPr>
        <p:spPr>
          <a:xfrm>
            <a:off x="6149880" y="8424720"/>
            <a:ext cx="21600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直接连接符 355"/>
          <p:cNvSpPr/>
          <p:nvPr/>
        </p:nvSpPr>
        <p:spPr>
          <a:xfrm flipV="1">
            <a:off x="6102360" y="7527960"/>
            <a:ext cx="0" cy="2160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TextBox 357"/>
          <p:cNvSpPr/>
          <p:nvPr/>
        </p:nvSpPr>
        <p:spPr>
          <a:xfrm>
            <a:off x="5862600" y="7351560"/>
            <a:ext cx="120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4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直接连接符 360"/>
          <p:cNvSpPr/>
          <p:nvPr/>
        </p:nvSpPr>
        <p:spPr>
          <a:xfrm flipV="1">
            <a:off x="6105600" y="7169040"/>
            <a:ext cx="0" cy="2160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Box 361"/>
          <p:cNvSpPr/>
          <p:nvPr/>
        </p:nvSpPr>
        <p:spPr>
          <a:xfrm>
            <a:off x="5865840" y="6991200"/>
            <a:ext cx="120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直接连接符 362"/>
          <p:cNvSpPr/>
          <p:nvPr/>
        </p:nvSpPr>
        <p:spPr>
          <a:xfrm flipV="1">
            <a:off x="6102360" y="6818040"/>
            <a:ext cx="0" cy="2156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Box 363"/>
          <p:cNvSpPr/>
          <p:nvPr/>
        </p:nvSpPr>
        <p:spPr>
          <a:xfrm>
            <a:off x="5862600" y="6640560"/>
            <a:ext cx="120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直接连接符 364"/>
          <p:cNvSpPr/>
          <p:nvPr/>
        </p:nvSpPr>
        <p:spPr>
          <a:xfrm flipV="1">
            <a:off x="6097680" y="6454800"/>
            <a:ext cx="0" cy="2160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TextBox 365"/>
          <p:cNvSpPr/>
          <p:nvPr/>
        </p:nvSpPr>
        <p:spPr>
          <a:xfrm>
            <a:off x="5888160" y="6278400"/>
            <a:ext cx="120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直接连接符 369"/>
          <p:cNvSpPr/>
          <p:nvPr/>
        </p:nvSpPr>
        <p:spPr>
          <a:xfrm flipV="1">
            <a:off x="6097680" y="6134040"/>
            <a:ext cx="0" cy="2160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TextBox 370"/>
          <p:cNvSpPr/>
          <p:nvPr/>
        </p:nvSpPr>
        <p:spPr>
          <a:xfrm>
            <a:off x="5865840" y="5958000"/>
            <a:ext cx="120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TextBox 371"/>
          <p:cNvSpPr/>
          <p:nvPr/>
        </p:nvSpPr>
        <p:spPr>
          <a:xfrm>
            <a:off x="5256360" y="7613640"/>
            <a:ext cx="78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13o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TextBox 372"/>
          <p:cNvSpPr/>
          <p:nvPr/>
        </p:nvSpPr>
        <p:spPr>
          <a:xfrm>
            <a:off x="5021280" y="7816680"/>
            <a:ext cx="78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GA20o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Box 373"/>
          <p:cNvSpPr/>
          <p:nvPr/>
        </p:nvSpPr>
        <p:spPr>
          <a:xfrm>
            <a:off x="5000760" y="8128080"/>
            <a:ext cx="78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GA20o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Box 374"/>
          <p:cNvSpPr/>
          <p:nvPr/>
        </p:nvSpPr>
        <p:spPr>
          <a:xfrm rot="16200000">
            <a:off x="5370480" y="7967160"/>
            <a:ext cx="78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GA3o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Box 375"/>
          <p:cNvSpPr/>
          <p:nvPr/>
        </p:nvSpPr>
        <p:spPr>
          <a:xfrm rot="16200000">
            <a:off x="5841720" y="7971840"/>
            <a:ext cx="78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GA20o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Box 376"/>
          <p:cNvSpPr/>
          <p:nvPr/>
        </p:nvSpPr>
        <p:spPr>
          <a:xfrm>
            <a:off x="6051600" y="7537320"/>
            <a:ext cx="78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GA20o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Box 377"/>
          <p:cNvSpPr/>
          <p:nvPr/>
        </p:nvSpPr>
        <p:spPr>
          <a:xfrm>
            <a:off x="6064200" y="7189920"/>
            <a:ext cx="78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GA20o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TextBox 378"/>
          <p:cNvSpPr/>
          <p:nvPr/>
        </p:nvSpPr>
        <p:spPr>
          <a:xfrm>
            <a:off x="6059520" y="6816600"/>
            <a:ext cx="78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GA20o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TextBox 379"/>
          <p:cNvSpPr/>
          <p:nvPr/>
        </p:nvSpPr>
        <p:spPr>
          <a:xfrm>
            <a:off x="6064200" y="6477120"/>
            <a:ext cx="78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GA3o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TextBox 380"/>
          <p:cNvSpPr/>
          <p:nvPr/>
        </p:nvSpPr>
        <p:spPr>
          <a:xfrm>
            <a:off x="6033960" y="6134040"/>
            <a:ext cx="78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GA2o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矩形 383"/>
          <p:cNvSpPr/>
          <p:nvPr/>
        </p:nvSpPr>
        <p:spPr>
          <a:xfrm>
            <a:off x="240840" y="5156280"/>
            <a:ext cx="75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sparagi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直接连接符 384"/>
          <p:cNvSpPr/>
          <p:nvPr/>
        </p:nvSpPr>
        <p:spPr>
          <a:xfrm flipH="1" flipV="1">
            <a:off x="785520" y="5722560"/>
            <a:ext cx="1258920" cy="126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TextBox 385"/>
          <p:cNvSpPr/>
          <p:nvPr/>
        </p:nvSpPr>
        <p:spPr>
          <a:xfrm>
            <a:off x="1916280" y="5079960"/>
            <a:ext cx="35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A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矩形 386"/>
          <p:cNvSpPr/>
          <p:nvPr/>
        </p:nvSpPr>
        <p:spPr>
          <a:xfrm>
            <a:off x="235440" y="5605560"/>
            <a:ext cx="66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spart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直接连接符 387"/>
          <p:cNvSpPr/>
          <p:nvPr/>
        </p:nvSpPr>
        <p:spPr>
          <a:xfrm flipV="1">
            <a:off x="603360" y="5363640"/>
            <a:ext cx="0" cy="2876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TextBox 388"/>
          <p:cNvSpPr/>
          <p:nvPr/>
        </p:nvSpPr>
        <p:spPr>
          <a:xfrm>
            <a:off x="50760" y="537840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sn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直接连接符 389"/>
          <p:cNvSpPr/>
          <p:nvPr/>
        </p:nvSpPr>
        <p:spPr>
          <a:xfrm>
            <a:off x="533520" y="5365800"/>
            <a:ext cx="0" cy="28728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Box 390"/>
          <p:cNvSpPr/>
          <p:nvPr/>
        </p:nvSpPr>
        <p:spPr>
          <a:xfrm>
            <a:off x="571680" y="537840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SP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直接连接符 391"/>
          <p:cNvSpPr/>
          <p:nvPr/>
        </p:nvSpPr>
        <p:spPr>
          <a:xfrm flipH="1" flipV="1">
            <a:off x="893520" y="5293800"/>
            <a:ext cx="2106360" cy="18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直接连接符 394"/>
          <p:cNvSpPr/>
          <p:nvPr/>
        </p:nvSpPr>
        <p:spPr>
          <a:xfrm>
            <a:off x="3005280" y="5288040"/>
            <a:ext cx="0" cy="360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TextBox 397"/>
          <p:cNvSpPr/>
          <p:nvPr/>
        </p:nvSpPr>
        <p:spPr>
          <a:xfrm>
            <a:off x="1143000" y="5497560"/>
            <a:ext cx="67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Asn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圆角矩形 398"/>
          <p:cNvSpPr/>
          <p:nvPr/>
        </p:nvSpPr>
        <p:spPr>
          <a:xfrm>
            <a:off x="63360" y="7723080"/>
            <a:ext cx="2293920" cy="1000080"/>
          </a:xfrm>
          <a:prstGeom prst="roundRect">
            <a:avLst>
              <a:gd name="adj" fmla="val 16667"/>
            </a:avLst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TextBox 403"/>
          <p:cNvSpPr/>
          <p:nvPr/>
        </p:nvSpPr>
        <p:spPr>
          <a:xfrm>
            <a:off x="3757680" y="6300720"/>
            <a:ext cx="726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Spermi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TextBox 404"/>
          <p:cNvSpPr/>
          <p:nvPr/>
        </p:nvSpPr>
        <p:spPr>
          <a:xfrm>
            <a:off x="3832200" y="7126200"/>
            <a:ext cx="69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D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TextBox 405"/>
          <p:cNvSpPr/>
          <p:nvPr/>
        </p:nvSpPr>
        <p:spPr>
          <a:xfrm>
            <a:off x="3857760" y="6967440"/>
            <a:ext cx="691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I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TextBox 406"/>
          <p:cNvSpPr/>
          <p:nvPr/>
        </p:nvSpPr>
        <p:spPr>
          <a:xfrm>
            <a:off x="3895560" y="6815160"/>
            <a:ext cx="69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P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Box 407"/>
          <p:cNvSpPr/>
          <p:nvPr/>
        </p:nvSpPr>
        <p:spPr>
          <a:xfrm>
            <a:off x="3941640" y="6661080"/>
            <a:ext cx="69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P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Box 408"/>
          <p:cNvSpPr/>
          <p:nvPr/>
        </p:nvSpPr>
        <p:spPr>
          <a:xfrm>
            <a:off x="3979800" y="6508800"/>
            <a:ext cx="69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PM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TextBox 251"/>
          <p:cNvSpPr/>
          <p:nvPr/>
        </p:nvSpPr>
        <p:spPr>
          <a:xfrm>
            <a:off x="487440" y="7742160"/>
            <a:ext cx="1701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Sucrose synthase (S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TextBox 253"/>
          <p:cNvSpPr/>
          <p:nvPr/>
        </p:nvSpPr>
        <p:spPr>
          <a:xfrm>
            <a:off x="409680" y="7999560"/>
            <a:ext cx="1701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Sucrose transport (SU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Box 256"/>
          <p:cNvSpPr/>
          <p:nvPr/>
        </p:nvSpPr>
        <p:spPr>
          <a:xfrm>
            <a:off x="271440" y="8202600"/>
            <a:ext cx="241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Sugar transport (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EDR,</a:t>
            </a: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STP,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WEET</a:t>
            </a:r>
            <a:r>
              <a:rPr b="0" lang="en-US" sz="1000" spc="-1" strike="noStrike">
                <a:solidFill>
                  <a:srgbClr val="ff0000"/>
                </a:solidFill>
                <a:latin typeface="Times New Roman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Box 257"/>
          <p:cNvSpPr/>
          <p:nvPr/>
        </p:nvSpPr>
        <p:spPr>
          <a:xfrm>
            <a:off x="54000" y="8423280"/>
            <a:ext cx="2373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Times New Roman"/>
              </a:rPr>
              <a:t>Sucrose synthesis and transpo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TextBox 262"/>
          <p:cNvSpPr/>
          <p:nvPr/>
        </p:nvSpPr>
        <p:spPr>
          <a:xfrm>
            <a:off x="2413080" y="8451720"/>
            <a:ext cx="228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Hormone siganatransductu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矩形 1"/>
          <p:cNvSpPr/>
          <p:nvPr/>
        </p:nvSpPr>
        <p:spPr>
          <a:xfrm>
            <a:off x="773280" y="8809200"/>
            <a:ext cx="609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10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SC losses affect multiple primary and secondly metabolism pathway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9-19T23:39:19Z</dcterms:created>
  <dc:creator>万丽云</dc:creator>
  <dc:description/>
  <dc:language>en-US</dc:language>
  <cp:lastModifiedBy>wly</cp:lastModifiedBy>
  <dcterms:modified xsi:type="dcterms:W3CDTF">2019-07-10T01:33:10Z</dcterms:modified>
  <cp:revision>24</cp:revision>
  <dc:subject/>
  <dc:title>幻灯片 1</dc:title>
</cp:coreProperties>
</file>